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101" autoAdjust="0"/>
    <p:restoredTop sz="94660"/>
  </p:normalViewPr>
  <p:slideViewPr>
    <p:cSldViewPr snapToGrid="0" showGuides="1">
      <p:cViewPr varScale="1">
        <p:scale>
          <a:sx n="152" d="100"/>
          <a:sy n="152" d="100"/>
        </p:scale>
        <p:origin x="116" y="3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029CB2-72C3-4CCD-A4B4-0EDF76E014DF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944C40-6D50-42F1-94F2-05EFFBCAB3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30113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0579F9-E3C5-47DB-BDB2-541872CD0D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87CFB98-D29D-443C-9C56-1BEBC1B7DA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33415B-BB51-4EDC-B193-AB566378E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B52A43-28EB-4D5C-AA6F-5A43F9951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5A4154-2F65-46AA-8AAA-0FB20C6FE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213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400D09-F18A-4E40-91E2-82DB4A2CF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1B8E37C-0F92-4A1D-AA5B-5A212199D1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D9275C-2266-4C25-A98F-3738FFEEA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D7D5C6-10D3-4578-9421-CA5BBC6EA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76E10E-A92E-4DB7-AC04-3678EC560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3912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5BAA04B-202B-41A3-BFEA-6550A7E402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9C62BEF-EB67-492F-9FD2-EC8435ACCE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BA22B44-6C2A-45E1-8645-5A96A10CE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716036-4057-4CE7-9F44-7F55AA642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985C8D-769C-48E1-8E27-E94E3C08D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0799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E113C5-924C-4EC8-8566-75D840F6CF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D1FB9D7-39F8-4034-BF8A-690E300627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566B59-DC5D-49D9-ABDA-EF77B2C2B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1C2DC7-7F72-469F-8384-971CC40F7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404D5F-D58F-43AC-9B7B-9AC2D8BAF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731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CE588C-E5A9-4B74-B8E3-C6BD3A7C8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46F082-6C2A-4CD9-BE8B-8204C737BD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CB3A50-0A0C-4AC5-A955-BDD9AE40F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1238F2-D63F-4DAC-B12B-C87038D0E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D08012-8E55-4004-BF60-4F86B4084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1718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657D7E-A6E7-417A-8C95-39C60A0CBB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9FCF5F-F1E4-41B4-9B1A-1D5F66DAC8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6E197F-6122-4DBF-880A-0FD68D3E4B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FF077B6-F2CF-4F5F-AC93-87B58C0EA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2F1094C-5AE2-4363-AA31-CCF4A991F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A89529B-084C-45EA-B819-3DA766234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520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044B2F-FA29-4CE1-8421-5ABF31A2C9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D73B10-A533-46AC-A8FB-67ED694A19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5B05AC1-A62B-44C2-A5E7-AEB05B7640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9C8FB9E-7B17-46CB-A238-0D6E5AB288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9C295FC-C905-45C5-98B4-7B60AC3EA8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3BCF1B3-302A-4319-91A7-E906F9E78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92EA452-3BD3-42AB-AE82-D933E977B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38500D9-504C-4681-96E4-A0269C0E8D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528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231A5F-2210-4D94-9BC9-2A528D807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8A4363E-2F04-4AD5-8965-C81A034B6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E5C9488-F6AE-421A-B9D2-0C2F035D7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045E449-2CB1-4691-9A70-604C8B0AF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757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E0C3585-A661-47C0-8D45-8267B4317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32DA688-062C-4903-AADF-01692CDCE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0064052-E923-40D4-A4DC-31182003D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040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88CE8C-199A-40B9-BA5C-0F4AF0386D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08A05F7-0FF1-4EAC-AB06-A2CD4C7A74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C85FC87-2034-4B41-A4F8-AF79AF8C42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4A202B8-6F03-4B0B-85B1-9DC6AAE51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EEACE76-87A9-41A4-89AA-14CA56DA0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BABF9A-6157-4690-A7E3-8B50AD056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08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D8A454-BD39-4257-BDD8-4521DBD25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5F824B7-EEEC-484E-AF8C-22BE941983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B033EC-0CAE-4176-B11E-17D712EBE6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55A4C86-5A9A-44E0-9B55-ECDABC4A9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981D8EA-2A45-4639-9477-2598A30A6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BCA025F-E4B1-4882-9432-D7421CEA6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299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93B6E63-4809-4C2C-911E-ECD42C453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BD250A8-D5DE-48AE-8C18-56DFD1530B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01FDB3-50D6-44A0-9FDB-33F165C4A3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6263ED-5D48-4105-B963-22862624C5FA}" type="datetimeFigureOut">
              <a:rPr kumimoji="1" lang="ja-JP" altLang="en-US" smtClean="0"/>
              <a:pPr/>
              <a:t>2020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AFF5F3-EB9B-4510-A3DD-3E8CFFBF80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DF0F45-17E5-4BA2-9D37-E8D7A71796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C373B-FEE1-476C-8F86-669A3A444F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028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BAF6964-094E-4FD3-916F-372B33AE82C1}"/>
              </a:ext>
            </a:extLst>
          </p:cNvPr>
          <p:cNvSpPr txBox="1"/>
          <p:nvPr/>
        </p:nvSpPr>
        <p:spPr>
          <a:xfrm>
            <a:off x="286393" y="318448"/>
            <a:ext cx="5682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.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tion rate and dropout rate according to road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ance and required time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A6A8C586-C6A0-4996-A48C-8D2860EE63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1521458"/>
              </p:ext>
            </p:extLst>
          </p:nvPr>
        </p:nvGraphicFramePr>
        <p:xfrm>
          <a:off x="353833" y="640487"/>
          <a:ext cx="11048339" cy="5408148"/>
        </p:xfrm>
        <a:graphic>
          <a:graphicData uri="http://schemas.openxmlformats.org/drawingml/2006/table">
            <a:tbl>
              <a:tblPr/>
              <a:tblGrid>
                <a:gridCol w="195325">
                  <a:extLst>
                    <a:ext uri="{9D8B030D-6E8A-4147-A177-3AD203B41FA5}">
                      <a16:colId xmlns:a16="http://schemas.microsoft.com/office/drawing/2014/main" val="3823044549"/>
                    </a:ext>
                  </a:extLst>
                </a:gridCol>
                <a:gridCol w="925809">
                  <a:extLst>
                    <a:ext uri="{9D8B030D-6E8A-4147-A177-3AD203B41FA5}">
                      <a16:colId xmlns:a16="http://schemas.microsoft.com/office/drawing/2014/main" val="1734244797"/>
                    </a:ext>
                  </a:extLst>
                </a:gridCol>
                <a:gridCol w="834887">
                  <a:extLst>
                    <a:ext uri="{9D8B030D-6E8A-4147-A177-3AD203B41FA5}">
                      <a16:colId xmlns:a16="http://schemas.microsoft.com/office/drawing/2014/main" val="2520772882"/>
                    </a:ext>
                  </a:extLst>
                </a:gridCol>
                <a:gridCol w="699676">
                  <a:extLst>
                    <a:ext uri="{9D8B030D-6E8A-4147-A177-3AD203B41FA5}">
                      <a16:colId xmlns:a16="http://schemas.microsoft.com/office/drawing/2014/main" val="2720754581"/>
                    </a:ext>
                  </a:extLst>
                </a:gridCol>
                <a:gridCol w="673742">
                  <a:extLst>
                    <a:ext uri="{9D8B030D-6E8A-4147-A177-3AD203B41FA5}">
                      <a16:colId xmlns:a16="http://schemas.microsoft.com/office/drawing/2014/main" val="4216893305"/>
                    </a:ext>
                  </a:extLst>
                </a:gridCol>
                <a:gridCol w="399918">
                  <a:extLst>
                    <a:ext uri="{9D8B030D-6E8A-4147-A177-3AD203B41FA5}">
                      <a16:colId xmlns:a16="http://schemas.microsoft.com/office/drawing/2014/main" val="1953702683"/>
                    </a:ext>
                  </a:extLst>
                </a:gridCol>
                <a:gridCol w="925113">
                  <a:extLst>
                    <a:ext uri="{9D8B030D-6E8A-4147-A177-3AD203B41FA5}">
                      <a16:colId xmlns:a16="http://schemas.microsoft.com/office/drawing/2014/main" val="1122659701"/>
                    </a:ext>
                  </a:extLst>
                </a:gridCol>
                <a:gridCol w="344932">
                  <a:extLst>
                    <a:ext uri="{9D8B030D-6E8A-4147-A177-3AD203B41FA5}">
                      <a16:colId xmlns:a16="http://schemas.microsoft.com/office/drawing/2014/main" val="315326"/>
                    </a:ext>
                  </a:extLst>
                </a:gridCol>
                <a:gridCol w="594559">
                  <a:extLst>
                    <a:ext uri="{9D8B030D-6E8A-4147-A177-3AD203B41FA5}">
                      <a16:colId xmlns:a16="http://schemas.microsoft.com/office/drawing/2014/main" val="3665348074"/>
                    </a:ext>
                  </a:extLst>
                </a:gridCol>
                <a:gridCol w="477084">
                  <a:extLst>
                    <a:ext uri="{9D8B030D-6E8A-4147-A177-3AD203B41FA5}">
                      <a16:colId xmlns:a16="http://schemas.microsoft.com/office/drawing/2014/main" val="2662725996"/>
                    </a:ext>
                  </a:extLst>
                </a:gridCol>
                <a:gridCol w="707442">
                  <a:extLst>
                    <a:ext uri="{9D8B030D-6E8A-4147-A177-3AD203B41FA5}">
                      <a16:colId xmlns:a16="http://schemas.microsoft.com/office/drawing/2014/main" val="2875626685"/>
                    </a:ext>
                  </a:extLst>
                </a:gridCol>
                <a:gridCol w="686219">
                  <a:extLst>
                    <a:ext uri="{9D8B030D-6E8A-4147-A177-3AD203B41FA5}">
                      <a16:colId xmlns:a16="http://schemas.microsoft.com/office/drawing/2014/main" val="1666615886"/>
                    </a:ext>
                  </a:extLst>
                </a:gridCol>
                <a:gridCol w="551191">
                  <a:extLst>
                    <a:ext uri="{9D8B030D-6E8A-4147-A177-3AD203B41FA5}">
                      <a16:colId xmlns:a16="http://schemas.microsoft.com/office/drawing/2014/main" val="1777786903"/>
                    </a:ext>
                  </a:extLst>
                </a:gridCol>
                <a:gridCol w="511176">
                  <a:extLst>
                    <a:ext uri="{9D8B030D-6E8A-4147-A177-3AD203B41FA5}">
                      <a16:colId xmlns:a16="http://schemas.microsoft.com/office/drawing/2014/main" val="3070269857"/>
                    </a:ext>
                  </a:extLst>
                </a:gridCol>
                <a:gridCol w="847515">
                  <a:extLst>
                    <a:ext uri="{9D8B030D-6E8A-4147-A177-3AD203B41FA5}">
                      <a16:colId xmlns:a16="http://schemas.microsoft.com/office/drawing/2014/main" val="2470607302"/>
                    </a:ext>
                  </a:extLst>
                </a:gridCol>
                <a:gridCol w="699095">
                  <a:extLst>
                    <a:ext uri="{9D8B030D-6E8A-4147-A177-3AD203B41FA5}">
                      <a16:colId xmlns:a16="http://schemas.microsoft.com/office/drawing/2014/main" val="2527093081"/>
                    </a:ext>
                  </a:extLst>
                </a:gridCol>
                <a:gridCol w="463702">
                  <a:extLst>
                    <a:ext uri="{9D8B030D-6E8A-4147-A177-3AD203B41FA5}">
                      <a16:colId xmlns:a16="http://schemas.microsoft.com/office/drawing/2014/main" val="1562585787"/>
                    </a:ext>
                  </a:extLst>
                </a:gridCol>
                <a:gridCol w="385309">
                  <a:extLst>
                    <a:ext uri="{9D8B030D-6E8A-4147-A177-3AD203B41FA5}">
                      <a16:colId xmlns:a16="http://schemas.microsoft.com/office/drawing/2014/main" val="2680976429"/>
                    </a:ext>
                  </a:extLst>
                </a:gridCol>
                <a:gridCol w="125645">
                  <a:extLst>
                    <a:ext uri="{9D8B030D-6E8A-4147-A177-3AD203B41FA5}">
                      <a16:colId xmlns:a16="http://schemas.microsoft.com/office/drawing/2014/main" val="340083071"/>
                    </a:ext>
                  </a:extLst>
                </a:gridCol>
              </a:tblGrid>
              <a:tr h="229642">
                <a:tc>
                  <a:txBody>
                    <a:bodyPr/>
                    <a:lstStyle/>
                    <a:p>
                      <a:pPr algn="l" rtl="0" fontAlgn="ctr"/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rticipation rate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8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ropout rate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4010892"/>
                  </a:ext>
                </a:extLst>
              </a:tr>
              <a:tr h="229642">
                <a:tc>
                  <a:txBody>
                    <a:bodyPr/>
                    <a:lstStyle/>
                    <a:p>
                      <a:pPr algn="l" rtl="0" fontAlgn="ctr"/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oad distanc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algn="r"/>
                      <a:r>
                        <a:rPr kumimoji="1" lang="en-US" altLang="ja-JP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rticipation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n</a:t>
                      </a:r>
                      <a:endParaRPr kumimoji="1" lang="ja-JP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899" marR="3899" marT="3899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3899" marR="3899" marT="3899" marB="0" anchor="ctr">
                    <a:lnL w="12700" cmpd="sng">
                      <a:noFill/>
                      <a:prstDash val="soli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equired time</a:t>
                      </a:r>
                    </a:p>
                  </a:txBody>
                  <a:tcPr marL="3899" marR="3899" marT="3899" marB="0" anchor="ctr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algn="r"/>
                      <a:r>
                        <a:rPr kumimoji="1" lang="en-US" altLang="ja-JP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rticipation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n</a:t>
                      </a:r>
                      <a:endParaRPr kumimoji="1" lang="ja-JP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oad distanc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rticipation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lus dropout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n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Dropout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equired time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rticipation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lus dropout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n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Dropout</a:t>
                      </a:r>
                    </a:p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0870062"/>
                  </a:ext>
                </a:extLst>
              </a:tr>
              <a:tr h="168387">
                <a:tc>
                  <a:txBody>
                    <a:bodyPr/>
                    <a:lstStyle/>
                    <a:p>
                      <a:pPr algn="l" rtl="0" fontAlgn="ctr"/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8312946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t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6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90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6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9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0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4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5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36346501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69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74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4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3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0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3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705578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5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2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8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3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21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624348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1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3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5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5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34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2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4088568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CI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2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6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84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9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83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7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3569358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9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86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4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8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6527553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77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86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2602760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7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9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9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7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5507187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BG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09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66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9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3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0507730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6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2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6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2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5272076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9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6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3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31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8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1575892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41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3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9932136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alvular surgery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7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2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4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6457467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6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2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0654141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7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4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21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272355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7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1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5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4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3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7498631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F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4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6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9572802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4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0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4)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4491183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4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3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313497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1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3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8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7468471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A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7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8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7068413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42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379198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33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6497164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1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6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5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8264885"/>
                  </a:ext>
                </a:extLst>
              </a:tr>
              <a:tr h="78681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TAA/AAA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8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10 (km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9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0-30 (mi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4438259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9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0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9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-2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9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4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-6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1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7800308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5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26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1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0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30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-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4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-180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3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6917919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9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11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7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2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18)</a:t>
                      </a: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km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19)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   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≥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0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(min)</a:t>
                      </a: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21)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4967661"/>
                  </a:ext>
                </a:extLst>
              </a:tr>
              <a:tr h="160560"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899" marR="3899" marT="38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3065843"/>
                  </a:ext>
                </a:extLst>
              </a:tr>
            </a:tbl>
          </a:graphicData>
        </a:graphic>
      </p:graphicFrame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6D1ED80-08CE-4456-83F4-CE65DF6AFE16}"/>
              </a:ext>
            </a:extLst>
          </p:cNvPr>
          <p:cNvSpPr/>
          <p:nvPr/>
        </p:nvSpPr>
        <p:spPr>
          <a:xfrm>
            <a:off x="353833" y="6124453"/>
            <a:ext cx="1092906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I; percutaneous coronary intervention; CABG, coronary artery bypass grafting; CHF, congestive heart failure; DA, dissecting aneurysm of the aorta; TAA/AAA, thoracic/abdominal aortic aneurysm</a:t>
            </a:r>
          </a:p>
        </p:txBody>
      </p:sp>
    </p:spTree>
    <p:extLst>
      <p:ext uri="{BB962C8B-B14F-4D97-AF65-F5344CB8AC3E}">
        <p14:creationId xmlns:p14="http://schemas.microsoft.com/office/powerpoint/2010/main" val="4253366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9</TotalTime>
  <Words>1189</Words>
  <Application>Microsoft Office PowerPoint</Application>
  <PresentationFormat>ワイド画面</PresentationFormat>
  <Paragraphs>48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TSUKO NAKAYAMA</dc:creator>
  <cp:lastModifiedBy>ATSUKO NAKAYAMA</cp:lastModifiedBy>
  <cp:revision>56</cp:revision>
  <dcterms:created xsi:type="dcterms:W3CDTF">2020-08-26T00:11:12Z</dcterms:created>
  <dcterms:modified xsi:type="dcterms:W3CDTF">2020-11-25T05:56:01Z</dcterms:modified>
</cp:coreProperties>
</file>